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F2C19-A504-49EC-B2FC-66C6518BA4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D68B0-91CF-4314-A3E9-1847784B6F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2A9FC-B7A1-463E-9947-145E3A51F9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19CFD-4C9F-489B-A5BE-ADE9066182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28D5B-C391-46CD-AED0-E573EB541F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685D2-0618-40A5-B7E4-D684F3B2D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F4C11-3805-4F2C-84D4-E6D9BB6E71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6753F-6425-48FF-9F31-8825AAF79E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90247-8357-416E-9468-96C5F1F8A1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DB5AA-FF17-45EF-89B9-B483B419EF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88DDE-C3F6-4CBB-BEE6-B511684D87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AD0E6-AE2C-4E4E-A050-5C1AB6BA44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2EF643-FA7B-4DA1-9A3B-38129BF5D9E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Rajesh\Desktop\AIIMS\26 08 2016\UNSTAINED\FSC Vs GFP.jpeg"/>
          <p:cNvPicPr/>
          <p:nvPr/>
        </p:nvPicPr>
        <p:blipFill>
          <a:blip r:embed="rId1"/>
          <a:stretch/>
        </p:blipFill>
        <p:spPr>
          <a:xfrm>
            <a:off x="838080" y="533520"/>
            <a:ext cx="2151360" cy="1654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C:\Users\Rajesh\Desktop\AIIMS\26 08 2016\UNSTAINED\FSC Vs SSC.jpeg"/>
          <p:cNvPicPr/>
          <p:nvPr/>
        </p:nvPicPr>
        <p:blipFill>
          <a:blip r:embed="rId2"/>
          <a:stretch/>
        </p:blipFill>
        <p:spPr>
          <a:xfrm>
            <a:off x="2984400" y="539640"/>
            <a:ext cx="2578320" cy="16480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C:\Users\Rajesh\Desktop\AIIMS\26 08 2016\STAINED\FSC Vs GFP.jpeg"/>
          <p:cNvPicPr/>
          <p:nvPr/>
        </p:nvPicPr>
        <p:blipFill>
          <a:blip r:embed="rId3"/>
          <a:stretch/>
        </p:blipFill>
        <p:spPr>
          <a:xfrm>
            <a:off x="919080" y="2193840"/>
            <a:ext cx="2160720" cy="19209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" descr="C:\Users\Rajesh\Desktop\AIIMS\26 08 2016\STAINED\FSC Vs SSC.jpeg"/>
          <p:cNvPicPr/>
          <p:nvPr/>
        </p:nvPicPr>
        <p:blipFill>
          <a:blip r:embed="rId4"/>
          <a:stretch/>
        </p:blipFill>
        <p:spPr>
          <a:xfrm>
            <a:off x="3289320" y="2244600"/>
            <a:ext cx="2201760" cy="1785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C:\Users\Rajesh\Desktop\AIIMS\8 09 2016\PRE SORT\FSC Vs GFP.jpeg"/>
          <p:cNvPicPr/>
          <p:nvPr/>
        </p:nvPicPr>
        <p:blipFill>
          <a:blip r:embed="rId5"/>
          <a:stretch/>
        </p:blipFill>
        <p:spPr>
          <a:xfrm>
            <a:off x="990720" y="4818240"/>
            <a:ext cx="2286000" cy="1600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C:\Users\Rajesh\Desktop\AIIMS\8 09 2016\PRE SORT\FSC Vs SSC.jpeg"/>
          <p:cNvPicPr/>
          <p:nvPr/>
        </p:nvPicPr>
        <p:blipFill>
          <a:blip r:embed="rId6"/>
          <a:stretch/>
        </p:blipFill>
        <p:spPr>
          <a:xfrm>
            <a:off x="3429000" y="4818240"/>
            <a:ext cx="2133720" cy="15238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" descr="C:\Users\Rajesh\Desktop\AIIMS\8 09 2016\PS\FSC Vs GFP.jpeg"/>
          <p:cNvPicPr/>
          <p:nvPr/>
        </p:nvPicPr>
        <p:blipFill>
          <a:blip r:embed="rId7"/>
          <a:stretch/>
        </p:blipFill>
        <p:spPr>
          <a:xfrm>
            <a:off x="1066680" y="6440400"/>
            <a:ext cx="2133720" cy="17067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3" descr="C:\Users\Rajesh\Desktop\AIIMS\8 09 2016\PS\FSC Vs SSC.jpeg"/>
          <p:cNvPicPr/>
          <p:nvPr/>
        </p:nvPicPr>
        <p:blipFill>
          <a:blip r:embed="rId8"/>
          <a:stretch/>
        </p:blipFill>
        <p:spPr>
          <a:xfrm>
            <a:off x="3505320" y="6364440"/>
            <a:ext cx="2133360" cy="1823760"/>
          </a:xfrm>
          <a:prstGeom prst="rect">
            <a:avLst/>
          </a:prstGeom>
          <a:ln w="0">
            <a:noFill/>
          </a:ln>
        </p:spPr>
      </p:pic>
      <p:sp>
        <p:nvSpPr>
          <p:cNvPr id="49" name="TextBox 14"/>
          <p:cNvSpPr/>
          <p:nvPr/>
        </p:nvSpPr>
        <p:spPr>
          <a:xfrm>
            <a:off x="685800" y="651204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7"/>
          <p:cNvSpPr/>
          <p:nvPr/>
        </p:nvSpPr>
        <p:spPr>
          <a:xfrm>
            <a:off x="533520" y="2286000"/>
            <a:ext cx="46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533520" y="5335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9"/>
          <p:cNvSpPr/>
          <p:nvPr/>
        </p:nvSpPr>
        <p:spPr>
          <a:xfrm>
            <a:off x="685800" y="47242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c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0"/>
          <p:cNvSpPr/>
          <p:nvPr/>
        </p:nvSpPr>
        <p:spPr>
          <a:xfrm>
            <a:off x="1224000" y="4114800"/>
            <a:ext cx="3276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Events shown i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Arial"/>
              </a:rPr>
              <a:t>Black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: Total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ff0000"/>
                </a:solidFill>
                <a:latin typeface="Arial"/>
              </a:rPr>
              <a:t>Red: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 low/No GF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595959"/>
                </a:solidFill>
                <a:latin typeface="Arial"/>
              </a:rPr>
              <a:t>Grey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: High 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1"/>
          <p:cNvSpPr/>
          <p:nvPr/>
        </p:nvSpPr>
        <p:spPr>
          <a:xfrm>
            <a:off x="1371600" y="8116920"/>
            <a:ext cx="3276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Events shown i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Arial"/>
              </a:rPr>
              <a:t>Black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: Total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ff0000"/>
                </a:solidFill>
                <a:latin typeface="Arial"/>
              </a:rPr>
              <a:t>Red: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 high GFP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800" spc="-1" strike="noStrike">
                <a:solidFill>
                  <a:srgbClr val="9933ff"/>
                </a:solidFill>
                <a:latin typeface="Arial"/>
              </a:rPr>
              <a:t>Violet</a:t>
            </a:r>
            <a:r>
              <a:rPr b="1" lang="en-IN" sz="800" spc="-1" strike="noStrike">
                <a:solidFill>
                  <a:srgbClr val="000000"/>
                </a:solidFill>
                <a:latin typeface="Arial"/>
              </a:rPr>
              <a:t>:</a:t>
            </a:r>
            <a:r>
              <a:rPr b="0" lang="en-IN" sz="800" spc="-1" strike="noStrike">
                <a:solidFill>
                  <a:srgbClr val="000000"/>
                </a:solidFill>
                <a:latin typeface="Arial"/>
              </a:rPr>
              <a:t> low 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03T10:28:15Z</dcterms:created>
  <dc:creator>Naik</dc:creator>
  <dc:description/>
  <dc:language>en-US</dc:language>
  <cp:lastModifiedBy>Naik</cp:lastModifiedBy>
  <dcterms:modified xsi:type="dcterms:W3CDTF">2017-04-11T04:40:28Z</dcterms:modified>
  <cp:revision>6</cp:revision>
  <dc:subject/>
  <dc:title>Slide 1</dc:title>
</cp:coreProperties>
</file>